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  <p:sldId id="259" r:id="rId4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38" autoAdjust="0"/>
    <p:restoredTop sz="94660"/>
  </p:normalViewPr>
  <p:slideViewPr>
    <p:cSldViewPr snapToGrid="0" showGuides="1">
      <p:cViewPr varScale="1">
        <p:scale>
          <a:sx n="58" d="100"/>
          <a:sy n="58" d="100"/>
        </p:scale>
        <p:origin x="1964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944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013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07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5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05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23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547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717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844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607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779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371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/>
          <p:cNvSpPr/>
          <p:nvPr/>
        </p:nvSpPr>
        <p:spPr>
          <a:xfrm>
            <a:off x="0" y="0"/>
            <a:ext cx="6858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000" b="1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6 </a:t>
            </a:r>
            <a:r>
              <a:rPr lang="en-US" sz="10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ig. </a:t>
            </a:r>
            <a:r>
              <a:rPr lang="en-US" sz="1000" b="1" dirty="0"/>
              <a:t>HIF-1 direct targets </a:t>
            </a:r>
            <a:r>
              <a:rPr lang="en-US" sz="1000" b="1" dirty="0" err="1"/>
              <a:t>ChIP-seq</a:t>
            </a:r>
            <a:r>
              <a:rPr lang="en-US" sz="1000" b="1"/>
              <a:t> IGB signals </a:t>
            </a:r>
            <a:r>
              <a:rPr lang="en-US" sz="1000" b="1" smtClean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omosome X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minimum number for the y-axis scale was the normalized average input tag count, and the maximum number was the average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ag count (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9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able). The WIG file for IGB was provided in GEO database (accession number </a:t>
            </a:r>
            <a:r>
              <a:rPr lang="en-US" sz="1000" dirty="0"/>
              <a:t>GSE228846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0" y="1040928"/>
            <a:ext cx="17047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02E1.1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0802" y="3681810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52D1.2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15875" y="6338834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0310.3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750" y="1274322"/>
            <a:ext cx="4790769" cy="2326154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3150526" y="3008798"/>
            <a:ext cx="108046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M02E1.1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776" y="3906044"/>
            <a:ext cx="4790769" cy="2326154"/>
          </a:xfrm>
          <a:prstGeom prst="rect">
            <a:avLst/>
          </a:prstGeom>
        </p:spPr>
      </p:pic>
      <p:sp>
        <p:nvSpPr>
          <p:cNvPr id="35" name="TextBox 34"/>
          <p:cNvSpPr txBox="1"/>
          <p:nvPr/>
        </p:nvSpPr>
        <p:spPr>
          <a:xfrm>
            <a:off x="4131921" y="5334952"/>
            <a:ext cx="10595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52D1.2</a:t>
            </a: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636" y="6693998"/>
            <a:ext cx="4790769" cy="2326154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2678020" y="8573869"/>
            <a:ext cx="10595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0310.3</a:t>
            </a:r>
          </a:p>
        </p:txBody>
      </p:sp>
      <p:grpSp>
        <p:nvGrpSpPr>
          <p:cNvPr id="28" name="Group 27"/>
          <p:cNvGrpSpPr/>
          <p:nvPr/>
        </p:nvGrpSpPr>
        <p:grpSpPr>
          <a:xfrm>
            <a:off x="282636" y="1216974"/>
            <a:ext cx="1152195" cy="1421772"/>
            <a:chOff x="470526" y="6079802"/>
            <a:chExt cx="1152195" cy="1421772"/>
          </a:xfrm>
        </p:grpSpPr>
        <p:sp>
          <p:nvSpPr>
            <p:cNvPr id="29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" name="Group 36"/>
          <p:cNvGrpSpPr/>
          <p:nvPr/>
        </p:nvGrpSpPr>
        <p:grpSpPr>
          <a:xfrm>
            <a:off x="363661" y="3933802"/>
            <a:ext cx="1152195" cy="1421772"/>
            <a:chOff x="470526" y="6079802"/>
            <a:chExt cx="1152195" cy="1421772"/>
          </a:xfrm>
        </p:grpSpPr>
        <p:sp>
          <p:nvSpPr>
            <p:cNvPr id="48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2" name="Group 51"/>
          <p:cNvGrpSpPr/>
          <p:nvPr/>
        </p:nvGrpSpPr>
        <p:grpSpPr>
          <a:xfrm>
            <a:off x="396414" y="6634137"/>
            <a:ext cx="1152195" cy="1421772"/>
            <a:chOff x="470526" y="6079802"/>
            <a:chExt cx="1152195" cy="1421772"/>
          </a:xfrm>
        </p:grpSpPr>
        <p:sp>
          <p:nvSpPr>
            <p:cNvPr id="53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86297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14E2.3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7" y="2645167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E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26C11.8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7" y="5397434"/>
            <a:ext cx="10910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F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40A1A.3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454" y="251486"/>
            <a:ext cx="4790769" cy="2326154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2716618" y="2078351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14E2.3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453" y="2849948"/>
            <a:ext cx="4790769" cy="2326154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2138247" y="4683327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26C11.8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327" y="5600960"/>
            <a:ext cx="4790769" cy="2326154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504040" y="7447590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40A1A.3</a:t>
            </a:r>
          </a:p>
        </p:txBody>
      </p:sp>
      <p:grpSp>
        <p:nvGrpSpPr>
          <p:cNvPr id="34" name="Group 33"/>
          <p:cNvGrpSpPr/>
          <p:nvPr/>
        </p:nvGrpSpPr>
        <p:grpSpPr>
          <a:xfrm>
            <a:off x="308775" y="211549"/>
            <a:ext cx="1152195" cy="1421772"/>
            <a:chOff x="470526" y="6079802"/>
            <a:chExt cx="1152195" cy="1421772"/>
          </a:xfrm>
        </p:grpSpPr>
        <p:sp>
          <p:nvSpPr>
            <p:cNvPr id="38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4" name="Group 43"/>
          <p:cNvGrpSpPr/>
          <p:nvPr/>
        </p:nvGrpSpPr>
        <p:grpSpPr>
          <a:xfrm>
            <a:off x="321357" y="2863925"/>
            <a:ext cx="1152195" cy="1421772"/>
            <a:chOff x="470526" y="6079802"/>
            <a:chExt cx="1152195" cy="1421772"/>
          </a:xfrm>
        </p:grpSpPr>
        <p:sp>
          <p:nvSpPr>
            <p:cNvPr id="45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9" name="Group 48"/>
          <p:cNvGrpSpPr/>
          <p:nvPr/>
        </p:nvGrpSpPr>
        <p:grpSpPr>
          <a:xfrm>
            <a:off x="321357" y="5600960"/>
            <a:ext cx="1152195" cy="1421772"/>
            <a:chOff x="470526" y="6079802"/>
            <a:chExt cx="1152195" cy="1421772"/>
          </a:xfrm>
        </p:grpSpPr>
        <p:sp>
          <p:nvSpPr>
            <p:cNvPr id="50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623467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G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ZK1073.2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7856" y="2645167"/>
            <a:ext cx="14507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H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33E10.8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031" y="224153"/>
            <a:ext cx="4790769" cy="2326154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4056823" y="2068150"/>
            <a:ext cx="1249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ZK1073.2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754" y="2930203"/>
            <a:ext cx="4790769" cy="2326154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4400346" y="4774012"/>
            <a:ext cx="9059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33E10.8</a:t>
            </a:r>
          </a:p>
        </p:txBody>
      </p:sp>
      <p:grpSp>
        <p:nvGrpSpPr>
          <p:cNvPr id="18" name="Group 17"/>
          <p:cNvGrpSpPr/>
          <p:nvPr/>
        </p:nvGrpSpPr>
        <p:grpSpPr>
          <a:xfrm>
            <a:off x="251303" y="219041"/>
            <a:ext cx="1152195" cy="1421772"/>
            <a:chOff x="470526" y="6079802"/>
            <a:chExt cx="1152195" cy="1421772"/>
          </a:xfrm>
        </p:grpSpPr>
        <p:sp>
          <p:nvSpPr>
            <p:cNvPr id="25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4" name="Group 33"/>
          <p:cNvGrpSpPr/>
          <p:nvPr/>
        </p:nvGrpSpPr>
        <p:grpSpPr>
          <a:xfrm>
            <a:off x="336362" y="2930203"/>
            <a:ext cx="1152195" cy="1421772"/>
            <a:chOff x="470526" y="6079802"/>
            <a:chExt cx="1152195" cy="1421772"/>
          </a:xfrm>
        </p:grpSpPr>
        <p:sp>
          <p:nvSpPr>
            <p:cNvPr id="37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47486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9</TotalTime>
  <Words>161</Words>
  <Application>Microsoft Office PowerPoint</Application>
  <PresentationFormat>On-screen Show (4:3)</PresentationFormat>
  <Paragraphs>4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SimSun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ngxia</dc:creator>
  <cp:lastModifiedBy>Dingxia</cp:lastModifiedBy>
  <cp:revision>38</cp:revision>
  <cp:lastPrinted>2023-01-23T06:24:09Z</cp:lastPrinted>
  <dcterms:created xsi:type="dcterms:W3CDTF">2023-01-23T06:15:50Z</dcterms:created>
  <dcterms:modified xsi:type="dcterms:W3CDTF">2023-10-23T07:45:11Z</dcterms:modified>
</cp:coreProperties>
</file>